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8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B47298-9CD8-45AA-ABD1-1D0C9F9E63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B2805C4-A52B-4AA1-BD38-A130862463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B034DFA-035F-49AF-88AC-E4540AAC7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280CAD-527B-4B06-BE77-531EF9069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D5796B-E5DD-4396-813D-435A1EACA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2493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FE0669-1DC8-41D7-B023-4340F9D387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4CB9D51-F2E4-4D43-AF27-BE9A1CC68B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13DCA1-045E-4713-B54D-ACC7EBFD3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F52F62-7577-4067-84FA-4CAE6A734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0EF972-3E4A-4798-B775-39489FD0A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0589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C9DF9AD-4696-4309-B915-533BF0B23D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37E8C8C-30E2-4402-AAE4-1915EC7D7B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789326-B7F2-46DA-8D76-FED4CF831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785CF9-4123-4A6E-B85D-7C372C3B7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AC958C-27AD-4899-9E75-0A77EF5B2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5501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FB31FA-A868-46DA-A1FA-EC629D81D1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1E2502-BE23-48FE-892D-AA0827F683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A2EC9E-A49F-402E-AAD7-944863539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1B50E3-A41C-4224-BEDD-3AA61AD3F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383EB7A-FAE5-4B0A-9C2A-B6CE08549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7424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AB4675-F18C-46BD-8B40-043FB4FF6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A567BE5-300B-4365-BC54-2E40489C7F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C01BA8-5925-4AA1-940A-B20B0DFBE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25EE90-604E-4BCE-8290-10445DFB3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86D868-1DA1-4105-8B4B-01BD67A50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2803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029830-B665-475F-9FB5-6325BB2D72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992511-0148-41B9-AAA6-A8DEB8C784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A038697-871B-4B6A-88F6-45E0C468DE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C2F971D-F178-4A4F-91C0-58156FD08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6BBED82-84D9-40D3-BE10-154837552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2A33E07-123B-48CF-A258-A63CEF52A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3645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FD845C-F0E1-491E-9228-9E4F3D010E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FCB4CB-6B69-4BAC-948C-7523C99DDA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A29C18E-0CE6-4C3A-A8A3-899F5F105A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0ED40CA-A937-4FE1-8B31-AAC656F142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70F482E-251C-4E19-BA27-B9F4C9CDA3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CA1E2AA-EDA7-40CB-B8C6-5640D530C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DDC6DEF-70AD-4982-A832-DE3E35D4F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B35FA4-5887-48B4-A547-E52EF341F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620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4E77E4-B231-4449-8583-17DD3E038E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58FCFD3-AD30-420D-9982-00C588556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718947C-F2A3-4300-B39E-A8E6CC8A4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8A003E-A399-4562-BC7B-C613E2D1E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276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97BAC91-21B8-44D8-A883-EABA85F30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0E34B1F-F000-407B-B250-66D980D95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5BCB1CA-365C-424B-9E48-08FDD7B2F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5897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208CDA-C926-4062-AD2A-E6C9E6990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8E5BB21-59A9-4AFE-AA9F-74914EA446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DF20F6D-0E97-4E65-9F66-BC059EAE05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3945CD-48C4-4944-90DF-450F45F89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0856E9C-3548-4D2F-9E43-7E669ABEF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783FB7-A0FE-497D-A3F5-BD523D975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645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67B3E8-0F81-4D25-81F5-9837304DD6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3F23345-09BA-4F5F-8A51-7C850187BD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9F74530-0AED-4F78-84DB-5DC797049C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A77C38A-93C8-49A7-A5A2-D8F116432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2F791A5-0823-44F6-B21F-F3C73FB33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DD6AF7-0F53-4979-8E1A-44FE2B8F6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4719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A58B19D-6DF5-46E9-ACD3-1EBB02DF3A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D2512A-0633-4E68-B326-61D12D3D05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9FE8A7-4373-45CA-904B-2E7C8E91B6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6922F-F061-4AA8-BF24-1197D219BA37}" type="datetimeFigureOut">
              <a:rPr lang="zh-CN" altLang="en-US" smtClean="0"/>
              <a:t>2025/7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26C023-3D3E-4FD7-9880-BF175C67CA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0803DC-4724-4BD5-BCC1-3260EF89C9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EAEBB-CF74-47F3-944E-3A9AF52994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3177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E5BCEF03-775E-47D8-8245-D0CD67969E50}"/>
              </a:ext>
            </a:extLst>
          </p:cNvPr>
          <p:cNvSpPr/>
          <p:nvPr/>
        </p:nvSpPr>
        <p:spPr>
          <a:xfrm>
            <a:off x="598971" y="379214"/>
            <a:ext cx="51305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lasma membrane integrity assessment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24ED847B-4BA6-4BED-87CD-D6F9EEE4997C}"/>
              </a:ext>
            </a:extLst>
          </p:cNvPr>
          <p:cNvGrpSpPr/>
          <p:nvPr/>
        </p:nvGrpSpPr>
        <p:grpSpPr>
          <a:xfrm>
            <a:off x="478396" y="1407319"/>
            <a:ext cx="5352014" cy="4043362"/>
            <a:chOff x="859396" y="1559561"/>
            <a:chExt cx="5352014" cy="4043362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FF0F502A-B31A-440A-897B-A833CF2F2BC5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9396" y="1559561"/>
              <a:ext cx="5352014" cy="4043362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9" name="直接箭头连接符 8">
              <a:extLst>
                <a:ext uri="{FF2B5EF4-FFF2-40B4-BE49-F238E27FC236}">
                  <a16:creationId xmlns:a16="http://schemas.microsoft.com/office/drawing/2014/main" id="{BD3C9FCF-CBBA-4C97-9AC4-2EB86026A3BA}"/>
                </a:ext>
              </a:extLst>
            </p:cNvPr>
            <p:cNvCxnSpPr>
              <a:cxnSpLocks/>
            </p:cNvCxnSpPr>
            <p:nvPr/>
          </p:nvCxnSpPr>
          <p:spPr>
            <a:xfrm>
              <a:off x="2189480" y="4231640"/>
              <a:ext cx="111760" cy="294640"/>
            </a:xfrm>
            <a:prstGeom prst="straightConnector1">
              <a:avLst/>
            </a:prstGeom>
            <a:ln w="381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>
              <a:extLst>
                <a:ext uri="{FF2B5EF4-FFF2-40B4-BE49-F238E27FC236}">
                  <a16:creationId xmlns:a16="http://schemas.microsoft.com/office/drawing/2014/main" id="{6886D69A-FE3D-4743-8BCE-5CAE3E31278A}"/>
                </a:ext>
              </a:extLst>
            </p:cNvPr>
            <p:cNvCxnSpPr>
              <a:cxnSpLocks/>
            </p:cNvCxnSpPr>
            <p:nvPr/>
          </p:nvCxnSpPr>
          <p:spPr>
            <a:xfrm>
              <a:off x="1158240" y="1757680"/>
              <a:ext cx="325120" cy="86360"/>
            </a:xfrm>
            <a:prstGeom prst="straightConnector1">
              <a:avLst/>
            </a:prstGeom>
            <a:ln w="381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B16B6DCC-EBA2-43AF-B2E0-C3C14000BA27}"/>
                </a:ext>
              </a:extLst>
            </p:cNvPr>
            <p:cNvCxnSpPr>
              <a:cxnSpLocks/>
            </p:cNvCxnSpPr>
            <p:nvPr/>
          </p:nvCxnSpPr>
          <p:spPr>
            <a:xfrm>
              <a:off x="4516120" y="3037840"/>
              <a:ext cx="320040" cy="121920"/>
            </a:xfrm>
            <a:prstGeom prst="straightConnector1">
              <a:avLst/>
            </a:prstGeom>
            <a:ln w="381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箭头连接符 15">
              <a:extLst>
                <a:ext uri="{FF2B5EF4-FFF2-40B4-BE49-F238E27FC236}">
                  <a16:creationId xmlns:a16="http://schemas.microsoft.com/office/drawing/2014/main" id="{80A73821-1DDB-4757-85B0-347AE58C70A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45640" y="1844040"/>
              <a:ext cx="243840" cy="177800"/>
            </a:xfrm>
            <a:prstGeom prst="straightConnector1">
              <a:avLst/>
            </a:prstGeom>
            <a:ln w="3810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箭头连接符 17">
              <a:extLst>
                <a:ext uri="{FF2B5EF4-FFF2-40B4-BE49-F238E27FC236}">
                  <a16:creationId xmlns:a16="http://schemas.microsoft.com/office/drawing/2014/main" id="{C788C30F-4BCD-425A-844E-1329A834872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794760" y="3058160"/>
              <a:ext cx="259080" cy="101600"/>
            </a:xfrm>
            <a:prstGeom prst="straightConnector1">
              <a:avLst/>
            </a:prstGeom>
            <a:ln w="3810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Content Placeholder 6">
            <a:extLst>
              <a:ext uri="{FF2B5EF4-FFF2-40B4-BE49-F238E27FC236}">
                <a16:creationId xmlns:a16="http://schemas.microsoft.com/office/drawing/2014/main" id="{16C8B418-6642-4F51-B98C-CDF48C930C92}"/>
              </a:ext>
            </a:extLst>
          </p:cNvPr>
          <p:cNvSpPr txBox="1">
            <a:spLocks/>
          </p:cNvSpPr>
          <p:nvPr/>
        </p:nvSpPr>
        <p:spPr>
          <a:xfrm>
            <a:off x="6361592" y="2008505"/>
            <a:ext cx="5495731" cy="24571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buNone/>
            </a:pPr>
            <a:r>
              <a: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rPr>
              <a:t>Observe the curvature of the sperm tails under a 400× optical microscope. </a:t>
            </a:r>
          </a:p>
          <a:p>
            <a:pPr marL="0" indent="0" algn="just">
              <a:lnSpc>
                <a:spcPct val="150000"/>
              </a:lnSpc>
              <a:buNone/>
            </a:pPr>
            <a:r>
              <a: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rPr>
              <a:t>         : sperm with an intact plasma membrane</a:t>
            </a:r>
          </a:p>
          <a:p>
            <a:pPr marL="0" indent="0" algn="just">
              <a:lnSpc>
                <a:spcPct val="150000"/>
              </a:lnSpc>
              <a:buNone/>
            </a:pPr>
            <a:r>
              <a: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rPr>
              <a:t>         : sperm with a damaged plasma membrane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175CC334-B530-4C8E-9D5B-5FE54DC2BBD3}"/>
              </a:ext>
            </a:extLst>
          </p:cNvPr>
          <p:cNvCxnSpPr/>
          <p:nvPr/>
        </p:nvCxnSpPr>
        <p:spPr>
          <a:xfrm>
            <a:off x="6539499" y="3380198"/>
            <a:ext cx="344185" cy="0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4786BD89-F102-421C-8BA2-3EE6B8E2F3A2}"/>
              </a:ext>
            </a:extLst>
          </p:cNvPr>
          <p:cNvCxnSpPr/>
          <p:nvPr/>
        </p:nvCxnSpPr>
        <p:spPr>
          <a:xfrm>
            <a:off x="6539499" y="3969250"/>
            <a:ext cx="344185" cy="0"/>
          </a:xfrm>
          <a:prstGeom prst="straightConnector1">
            <a:avLst/>
          </a:prstGeom>
          <a:ln w="38100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26686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850A71E-D767-4B45-A533-2904939941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204" y="1551398"/>
            <a:ext cx="5479551" cy="4109663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B5525627-8A7B-4D76-ABAB-8674BD2B9C91}"/>
              </a:ext>
            </a:extLst>
          </p:cNvPr>
          <p:cNvSpPr/>
          <p:nvPr/>
        </p:nvSpPr>
        <p:spPr>
          <a:xfrm>
            <a:off x="598971" y="379214"/>
            <a:ext cx="42608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crosome integrity assessment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E3FAF235-6FD2-4873-9C10-4F3E22C3FE21}"/>
              </a:ext>
            </a:extLst>
          </p:cNvPr>
          <p:cNvSpPr txBox="1">
            <a:spLocks/>
          </p:cNvSpPr>
          <p:nvPr/>
        </p:nvSpPr>
        <p:spPr>
          <a:xfrm>
            <a:off x="6518638" y="2025970"/>
            <a:ext cx="5495731" cy="2457126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buNone/>
            </a:pPr>
            <a:r>
              <a: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rPr>
              <a:t>      In the absence of penetration, the PNA-FITC fluorescent dye binds to the inner membrane of the sperm acrosome but does not associate with the outer membrane. Therefore, intact sperm do not exhibit fluorescence with PNA-FITC, while sperm that have undergone the acrosome reaction lose their outer membrane and can bind to PNA-FITC, emitting green fluorescence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69267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912E6AC1-C1BB-405B-9BAD-A3A964E33D8F}"/>
              </a:ext>
            </a:extLst>
          </p:cNvPr>
          <p:cNvSpPr/>
          <p:nvPr/>
        </p:nvSpPr>
        <p:spPr>
          <a:xfrm>
            <a:off x="598971" y="379214"/>
            <a:ext cx="46135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uclear DNA integrity assessment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617BCAC3-8820-4591-869F-CF40D50C5F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888" y="1484614"/>
            <a:ext cx="5479200" cy="4109400"/>
          </a:xfrm>
          <a:prstGeom prst="rect">
            <a:avLst/>
          </a:prstGeom>
        </p:spPr>
      </p:pic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A3AFCEFC-C8BA-468D-88D2-A4DB2B45C517}"/>
              </a:ext>
            </a:extLst>
          </p:cNvPr>
          <p:cNvCxnSpPr>
            <a:cxnSpLocks/>
          </p:cNvCxnSpPr>
          <p:nvPr/>
        </p:nvCxnSpPr>
        <p:spPr>
          <a:xfrm>
            <a:off x="1946952" y="3429000"/>
            <a:ext cx="246403" cy="125617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6CCB09DE-C8BE-46FA-89D9-A36544462954}"/>
              </a:ext>
            </a:extLst>
          </p:cNvPr>
          <p:cNvCxnSpPr>
            <a:cxnSpLocks/>
          </p:cNvCxnSpPr>
          <p:nvPr/>
        </p:nvCxnSpPr>
        <p:spPr>
          <a:xfrm flipH="1" flipV="1">
            <a:off x="4908650" y="2546322"/>
            <a:ext cx="259080" cy="101600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0EA2DC58-3B2C-4C1C-A0AA-0DA5EC9DFCB2}"/>
              </a:ext>
            </a:extLst>
          </p:cNvPr>
          <p:cNvCxnSpPr>
            <a:cxnSpLocks/>
          </p:cNvCxnSpPr>
          <p:nvPr/>
        </p:nvCxnSpPr>
        <p:spPr>
          <a:xfrm flipH="1" flipV="1">
            <a:off x="4882793" y="3931621"/>
            <a:ext cx="259080" cy="101600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F45ADC34-FAF7-4792-8F96-72E4548474C2}"/>
              </a:ext>
            </a:extLst>
          </p:cNvPr>
          <p:cNvCxnSpPr>
            <a:cxnSpLocks/>
          </p:cNvCxnSpPr>
          <p:nvPr/>
        </p:nvCxnSpPr>
        <p:spPr>
          <a:xfrm>
            <a:off x="2032570" y="4385890"/>
            <a:ext cx="246403" cy="125617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5356CE4C-B0E3-4AE0-91DA-FDD52E7336F4}"/>
              </a:ext>
            </a:extLst>
          </p:cNvPr>
          <p:cNvGrpSpPr/>
          <p:nvPr/>
        </p:nvGrpSpPr>
        <p:grpSpPr>
          <a:xfrm>
            <a:off x="6503226" y="2200437"/>
            <a:ext cx="5495731" cy="2457126"/>
            <a:chOff x="6518638" y="2025970"/>
            <a:chExt cx="5495731" cy="2457126"/>
          </a:xfrm>
        </p:grpSpPr>
        <p:sp>
          <p:nvSpPr>
            <p:cNvPr id="12" name="Content Placeholder 6">
              <a:extLst>
                <a:ext uri="{FF2B5EF4-FFF2-40B4-BE49-F238E27FC236}">
                  <a16:creationId xmlns:a16="http://schemas.microsoft.com/office/drawing/2014/main" id="{086D1C93-9B3D-40FE-AE21-2146AA0D2C46}"/>
                </a:ext>
              </a:extLst>
            </p:cNvPr>
            <p:cNvSpPr txBox="1">
              <a:spLocks/>
            </p:cNvSpPr>
            <p:nvPr/>
          </p:nvSpPr>
          <p:spPr>
            <a:xfrm>
              <a:off x="6518638" y="2025970"/>
              <a:ext cx="5495731" cy="2457126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 fontScale="92500" lnSpcReduction="10000"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just">
                <a:lnSpc>
                  <a:spcPct val="150000"/>
                </a:lnSpc>
                <a:buNone/>
              </a:pPr>
              <a:r>
                <a:rPr lang="en-US" altLang="ko-KR" sz="200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Sperm were stained with 0.01% acridine orange staining solution (A0 staining solution, purchased from Solarbio Company) for observation.</a:t>
              </a:r>
            </a:p>
            <a:p>
              <a:pPr marL="0" indent="0" algn="just">
                <a:lnSpc>
                  <a:spcPct val="150000"/>
                </a:lnSpc>
                <a:buNone/>
              </a:pPr>
              <a:r>
                <a:rPr lang="en-US" altLang="ko-KR" sz="200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: Sperm with intact nuclear DNA</a:t>
              </a:r>
            </a:p>
            <a:p>
              <a:pPr marL="0" indent="0" algn="just">
                <a:lnSpc>
                  <a:spcPct val="150000"/>
                </a:lnSpc>
                <a:buNone/>
              </a:pPr>
              <a:r>
                <a:rPr lang="en-US" altLang="ko-KR" sz="200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: Sperm with damaged nuclear DNA</a:t>
              </a:r>
            </a:p>
            <a:p>
              <a:pPr marL="0" indent="0" algn="just">
                <a:lnSpc>
                  <a:spcPct val="150000"/>
                </a:lnSpc>
                <a:buNone/>
              </a:pPr>
              <a:endPara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indent="0" algn="just">
                <a:lnSpc>
                  <a:spcPct val="150000"/>
                </a:lnSpc>
                <a:buNone/>
              </a:pPr>
              <a:endPara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indent="0" algn="just">
                <a:lnSpc>
                  <a:spcPct val="150000"/>
                </a:lnSpc>
                <a:buNone/>
              </a:pPr>
              <a:endPara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indent="0" algn="just">
                <a:lnSpc>
                  <a:spcPct val="150000"/>
                </a:lnSpc>
                <a:buNone/>
              </a:pP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4D687349-303C-4EE2-AECF-EA4CA6F6020E}"/>
                </a:ext>
              </a:extLst>
            </p:cNvPr>
            <p:cNvCxnSpPr/>
            <p:nvPr/>
          </p:nvCxnSpPr>
          <p:spPr>
            <a:xfrm>
              <a:off x="6703886" y="3679905"/>
              <a:ext cx="344185" cy="0"/>
            </a:xfrm>
            <a:prstGeom prst="straightConnector1">
              <a:avLst/>
            </a:prstGeom>
            <a:ln w="381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箭头连接符 14">
              <a:extLst>
                <a:ext uri="{FF2B5EF4-FFF2-40B4-BE49-F238E27FC236}">
                  <a16:creationId xmlns:a16="http://schemas.microsoft.com/office/drawing/2014/main" id="{ACF2B7E4-B7AE-4CE8-9591-F49FEB63966D}"/>
                </a:ext>
              </a:extLst>
            </p:cNvPr>
            <p:cNvCxnSpPr/>
            <p:nvPr/>
          </p:nvCxnSpPr>
          <p:spPr>
            <a:xfrm>
              <a:off x="6703886" y="4155941"/>
              <a:ext cx="344185" cy="0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407967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">
            <a:extLst>
              <a:ext uri="{FF2B5EF4-FFF2-40B4-BE49-F238E27FC236}">
                <a16:creationId xmlns:a16="http://schemas.microsoft.com/office/drawing/2014/main" id="{DB3AA775-1E0A-4D0D-BF1C-663150C296B5}"/>
              </a:ext>
            </a:extLst>
          </p:cNvPr>
          <p:cNvSpPr txBox="1"/>
          <p:nvPr/>
        </p:nvSpPr>
        <p:spPr>
          <a:xfrm>
            <a:off x="1070688" y="893020"/>
            <a:ext cx="60975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T Sperm mitochondrial membrane potential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00F13E6-19A5-4B54-AA6D-E79786388F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738" y="1813388"/>
            <a:ext cx="5479200" cy="4109400"/>
          </a:xfrm>
          <a:prstGeom prst="rect">
            <a:avLst/>
          </a:prstGeom>
        </p:spPr>
      </p:pic>
      <p:sp>
        <p:nvSpPr>
          <p:cNvPr id="7" name="Content Placeholder 7">
            <a:extLst>
              <a:ext uri="{FF2B5EF4-FFF2-40B4-BE49-F238E27FC236}">
                <a16:creationId xmlns:a16="http://schemas.microsoft.com/office/drawing/2014/main" id="{BE07440D-B3CC-4065-89FC-7D9D837321D9}"/>
              </a:ext>
            </a:extLst>
          </p:cNvPr>
          <p:cNvSpPr txBox="1">
            <a:spLocks/>
          </p:cNvSpPr>
          <p:nvPr/>
        </p:nvSpPr>
        <p:spPr>
          <a:xfrm>
            <a:off x="6511369" y="1692419"/>
            <a:ext cx="5181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buNone/>
            </a:pPr>
            <a:r>
              <a:rPr lang="en-US" altLang="ko-KR" sz="2000">
                <a:latin typeface="Times New Roman" panose="02020603050405020304" pitchFamily="18" charset="0"/>
                <a:cs typeface="Times New Roman" panose="02020603050405020304" pitchFamily="18" charset="0"/>
              </a:rPr>
              <a:t>When the mitochondrial membrane potential is high, JC-1 accumulates in the matrix of mitochondria, forming a polymer (J-aggregates), which can produce red fluorescence.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n the mitochondrial membrane potential is low, JC-1 cannot accumulate in the matrix of the mitochondria, and JC-1 is a monomer, which can produce green fluorescence. the percentage of sperm with green fluorescence was statistically calculated as the proportion of the total number of counted sperm.</a:t>
            </a:r>
            <a:endParaRPr lang="ko-KR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9250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</TotalTime>
  <Words>236</Words>
  <Application>Microsoft Office PowerPoint</Application>
  <PresentationFormat>Widescreen</PresentationFormat>
  <Paragraphs>1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YY</dc:creator>
  <cp:lastModifiedBy>MDPI</cp:lastModifiedBy>
  <cp:revision>8</cp:revision>
  <dcterms:created xsi:type="dcterms:W3CDTF">2024-11-14T03:35:31Z</dcterms:created>
  <dcterms:modified xsi:type="dcterms:W3CDTF">2025-07-27T05:10:50Z</dcterms:modified>
</cp:coreProperties>
</file>